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Helle Formatvorlage 3 - Akz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240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7CC60B7-30BF-497D-903A-7A4E96D171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9C0D4160-70BB-49A5-8537-70E8DC4458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C2C897-2E60-423A-99ED-3D418A1A0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FAF14A-8213-43CF-91FE-B235B2F30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7A2FE86-48EC-4813-9347-2AEA7CEAB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987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945B9A-FDBD-426F-A502-2C4F4C8AC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FCE6265-A0E3-46F3-B65B-797AB6028F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7064A1F-A9D0-41D2-BF47-41A17EE84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CB13B0-DA7F-4335-9C17-7BA7D2C02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7D602DA-7C76-4055-94E9-3B5BEAFA5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5545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C1CA4AE-3707-4BF5-AC3E-F2854FBCB7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A841D93-AD03-4381-A488-7CCD7E4F9D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A1C84E-04E7-4AE2-AEA7-28C0593FC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3077BBE-35A9-4575-92E0-465A6D786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C240BB2-F051-4808-AA05-5A95A6BADF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2657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B80D5D-DBEB-4644-ABD5-92E851691F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122EA31-D568-4AE3-AF5F-9C98E887D0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112D40F-B133-48C8-9DFC-35C9FB0E7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E81F938-4C39-4E03-9525-A40D50F5C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F4026AB-D34F-4012-93BA-574144994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9248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547E8CC-9EC1-4229-A608-829B8D15C6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430324A-ABB8-4E66-8B85-891D2B90B1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FC77F7-844A-4E74-A6FE-E8C6B74AA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D6151CB-A33D-436E-86E3-735301660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59FB6D4-7851-4853-8A06-5DA1477E6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8670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00A703-ED52-4A91-AB0E-06D3FCE16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120FB4A-2491-4544-87C1-7183436FBC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FD70336-5E93-40FA-9FEF-EB73AD3D29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25BB56A-E815-4612-893F-89D051E89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659D5B6-F469-46AB-AEF3-BF0650483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B5F2B66-583B-4E09-92F5-3179D81AE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62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988BA8-0D5C-4F8A-AC34-C5A1887F8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4F24E87-C58D-4A2D-9285-8CFA16AA81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8F2E15D-120A-4D6D-A4D7-410354300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053E362-E760-4ED4-86E6-7BE9F20250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89C718E-8744-4811-9C49-DEB9B9C3E4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4D4315C-1DB7-41C8-8789-ED0D2F53AF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7F8926B1-D085-44B2-A34B-85945CB3B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588FE5A-5A2F-4EFE-9030-BD1EAB040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378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3585910-3C21-4F79-8930-37DCA59C2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D4EB0B2-7A5F-47D6-9B03-68ED4598E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C9EF9E5-30ED-4952-BFFB-CED8B3BEA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E4F998B-CF55-42E1-8CA3-DE5B46D05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8554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051D46D-A5B1-493D-9B02-DE65E6690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B3EACAA-8BC0-450D-9A40-D10C5B9D3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62DE0CA-1AFC-4615-A145-1766F77A0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1423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F229A5-43C7-42BE-8E72-60722A0CF0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657DD9E-B9C2-4EDA-8D0F-C00AE766D4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BD15539-958A-42F9-B1B9-569ED004E7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233787-34CD-4B94-8E82-691426CD8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2D83D1D-2D76-40D8-982C-FAEEEE19A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1D0823A-B941-4B42-AA02-7C9C753E4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5937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EAB4B8-C04F-4743-ADEA-66A45C062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CE86189-43F7-4BF4-8791-E020661E45A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D081D76-EA1E-4463-9C3F-18D2A9613D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7B94195-E184-4724-AE39-B426B2FC6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C7FE5D6-AECF-4897-8DFD-3BF471219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F360D46-EC2D-45B3-97E1-7808C92C0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4075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0679632-03A8-4BCE-B4BA-F04CD2849C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3D1C20E-EA3F-4BFD-B8A8-96682F6AC5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95546B-E12B-45E3-80E2-07B53F50B5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1C15F-062D-4B06-9E3A-C1C676BF67C8}" type="datetimeFigureOut">
              <a:rPr lang="de-DE" smtClean="0"/>
              <a:t>12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FE3C63-EF91-44E0-BCFB-46A1FBBEB3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F6AD52E-DE87-447C-8A42-8F751DF252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90D5E-6569-48C2-AC6A-CB6F473D19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2983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23BDCAE4-E31D-4DDD-B4E9-5A96F18496B5}"/>
              </a:ext>
            </a:extLst>
          </p:cNvPr>
          <p:cNvSpPr txBox="1"/>
          <p:nvPr/>
        </p:nvSpPr>
        <p:spPr>
          <a:xfrm>
            <a:off x="8335861" y="6431520"/>
            <a:ext cx="36111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* = In 4</a:t>
            </a:r>
            <a:r>
              <a:rPr lang="de-DE" sz="1000" baseline="30000"/>
              <a:t>th</a:t>
            </a:r>
            <a:r>
              <a:rPr lang="de-DE" sz="1000"/>
              <a:t> root transformed TOP 25, not in TOP 25 clr transformed</a:t>
            </a:r>
          </a:p>
          <a:p>
            <a:r>
              <a:rPr lang="de-DE" sz="1000" u="none" strike="noStrike" baseline="30000">
                <a:effectLst/>
              </a:rPr>
              <a:t>#</a:t>
            </a:r>
            <a:r>
              <a:rPr lang="de-DE" sz="1000"/>
              <a:t> = In clr transformed TOP 25, not in TOP 25 4</a:t>
            </a:r>
            <a:r>
              <a:rPr lang="de-DE" sz="1000" baseline="30000"/>
              <a:t>th</a:t>
            </a:r>
            <a:r>
              <a:rPr lang="de-DE" sz="1000"/>
              <a:t> root transformed</a:t>
            </a:r>
          </a:p>
          <a:p>
            <a:endParaRPr lang="de-DE" sz="1000"/>
          </a:p>
        </p:txBody>
      </p:sp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5543E323-074E-4041-83B9-D4E2B09A70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216492"/>
              </p:ext>
            </p:extLst>
          </p:nvPr>
        </p:nvGraphicFramePr>
        <p:xfrm>
          <a:off x="183573" y="1935122"/>
          <a:ext cx="4935546" cy="229758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22591">
                  <a:extLst>
                    <a:ext uri="{9D8B030D-6E8A-4147-A177-3AD203B41FA5}">
                      <a16:colId xmlns:a16="http://schemas.microsoft.com/office/drawing/2014/main" val="1610454659"/>
                    </a:ext>
                  </a:extLst>
                </a:gridCol>
                <a:gridCol w="822591">
                  <a:extLst>
                    <a:ext uri="{9D8B030D-6E8A-4147-A177-3AD203B41FA5}">
                      <a16:colId xmlns:a16="http://schemas.microsoft.com/office/drawing/2014/main" val="3765538093"/>
                    </a:ext>
                  </a:extLst>
                </a:gridCol>
                <a:gridCol w="822591">
                  <a:extLst>
                    <a:ext uri="{9D8B030D-6E8A-4147-A177-3AD203B41FA5}">
                      <a16:colId xmlns:a16="http://schemas.microsoft.com/office/drawing/2014/main" val="2746370186"/>
                    </a:ext>
                  </a:extLst>
                </a:gridCol>
                <a:gridCol w="822591">
                  <a:extLst>
                    <a:ext uri="{9D8B030D-6E8A-4147-A177-3AD203B41FA5}">
                      <a16:colId xmlns:a16="http://schemas.microsoft.com/office/drawing/2014/main" val="1222774298"/>
                    </a:ext>
                  </a:extLst>
                </a:gridCol>
                <a:gridCol w="822591">
                  <a:extLst>
                    <a:ext uri="{9D8B030D-6E8A-4147-A177-3AD203B41FA5}">
                      <a16:colId xmlns:a16="http://schemas.microsoft.com/office/drawing/2014/main" val="541238776"/>
                    </a:ext>
                  </a:extLst>
                </a:gridCol>
                <a:gridCol w="822591">
                  <a:extLst>
                    <a:ext uri="{9D8B030D-6E8A-4147-A177-3AD203B41FA5}">
                      <a16:colId xmlns:a16="http://schemas.microsoft.com/office/drawing/2014/main" val="1934745008"/>
                    </a:ext>
                  </a:extLst>
                </a:gridCol>
              </a:tblGrid>
              <a:tr h="287198">
                <a:tc>
                  <a:txBody>
                    <a:bodyPr/>
                    <a:lstStyle/>
                    <a:p>
                      <a:pPr algn="ctr" fontAlgn="ctr"/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Transformation: 4</a:t>
                      </a:r>
                      <a:r>
                        <a:rPr lang="de-DE" sz="1200" b="1" u="none" strike="noStrike" baseline="30000">
                          <a:solidFill>
                            <a:srgbClr val="000000"/>
                          </a:solidFill>
                          <a:effectLst/>
                        </a:rPr>
                        <a:t>th</a:t>
                      </a:r>
                      <a:r>
                        <a:rPr lang="de-DE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 root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1" u="none" strike="noStrike">
                          <a:solidFill>
                            <a:srgbClr val="000000"/>
                          </a:solidFill>
                          <a:effectLst/>
                        </a:rPr>
                        <a:t>Transformation: clr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070390561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Taxon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No. features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Accuracy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Kappa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Accuracy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>
                          <a:effectLst/>
                        </a:rPr>
                        <a:t>Kappa</a:t>
                      </a:r>
                      <a:endParaRPr lang="de-DE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7108189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Phylum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2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72.46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5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63.04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4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2131619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Clas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3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1.16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79.71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7553974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Order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1.88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1.16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2227538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Family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5.51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83.33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7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7726320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Genu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76.09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70.29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5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8412168"/>
                  </a:ext>
                </a:extLst>
              </a:tr>
              <a:tr h="28719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Species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39.89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.0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16.66 %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1398263"/>
                  </a:ext>
                </a:extLst>
              </a:tr>
            </a:tbl>
          </a:graphicData>
        </a:graphic>
      </p:graphicFrame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38E99C16-B0D7-4B73-8CF8-FA2881C3CD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0159203"/>
              </p:ext>
            </p:extLst>
          </p:nvPr>
        </p:nvGraphicFramePr>
        <p:xfrm>
          <a:off x="5174673" y="102435"/>
          <a:ext cx="6880200" cy="621153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894283">
                  <a:extLst>
                    <a:ext uri="{9D8B030D-6E8A-4147-A177-3AD203B41FA5}">
                      <a16:colId xmlns:a16="http://schemas.microsoft.com/office/drawing/2014/main" val="531568311"/>
                    </a:ext>
                  </a:extLst>
                </a:gridCol>
                <a:gridCol w="1687594">
                  <a:extLst>
                    <a:ext uri="{9D8B030D-6E8A-4147-A177-3AD203B41FA5}">
                      <a16:colId xmlns:a16="http://schemas.microsoft.com/office/drawing/2014/main" val="2664611138"/>
                    </a:ext>
                  </a:extLst>
                </a:gridCol>
                <a:gridCol w="894283">
                  <a:extLst>
                    <a:ext uri="{9D8B030D-6E8A-4147-A177-3AD203B41FA5}">
                      <a16:colId xmlns:a16="http://schemas.microsoft.com/office/drawing/2014/main" val="677635148"/>
                    </a:ext>
                  </a:extLst>
                </a:gridCol>
                <a:gridCol w="894283">
                  <a:extLst>
                    <a:ext uri="{9D8B030D-6E8A-4147-A177-3AD203B41FA5}">
                      <a16:colId xmlns:a16="http://schemas.microsoft.com/office/drawing/2014/main" val="4230636461"/>
                    </a:ext>
                  </a:extLst>
                </a:gridCol>
                <a:gridCol w="1615474">
                  <a:extLst>
                    <a:ext uri="{9D8B030D-6E8A-4147-A177-3AD203B41FA5}">
                      <a16:colId xmlns:a16="http://schemas.microsoft.com/office/drawing/2014/main" val="1880965101"/>
                    </a:ext>
                  </a:extLst>
                </a:gridCol>
                <a:gridCol w="894283">
                  <a:extLst>
                    <a:ext uri="{9D8B030D-6E8A-4147-A177-3AD203B41FA5}">
                      <a16:colId xmlns:a16="http://schemas.microsoft.com/office/drawing/2014/main" val="810493023"/>
                    </a:ext>
                  </a:extLst>
                </a:gridCol>
              </a:tblGrid>
              <a:tr h="166196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ormation: 4</a:t>
                      </a:r>
                      <a:r>
                        <a:rPr lang="de-DE" sz="10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</a:t>
                      </a: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root</a:t>
                      </a:r>
                    </a:p>
                  </a:txBody>
                  <a:tcPr marL="5494" marR="5494" marT="5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r>
                        <a:rPr lang="de-DE" sz="10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ormation_ 4th root</a:t>
                      </a:r>
                    </a:p>
                  </a:txBody>
                  <a:tcPr marL="5494" marR="5494" marT="54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de-DE" sz="105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4" marR="5494" marT="54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ormation: clr</a:t>
                      </a:r>
                    </a:p>
                  </a:txBody>
                  <a:tcPr marL="5494" marR="5494" marT="5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5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nsformation: clr</a:t>
                      </a:r>
                    </a:p>
                  </a:txBody>
                  <a:tcPr marL="5494" marR="5494" marT="54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5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4" marR="5494" marT="5494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952085"/>
                  </a:ext>
                </a:extLst>
              </a:tr>
              <a:tr h="326610"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>
                          <a:effectLst/>
                        </a:rPr>
                        <a:t>Rank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4" marR="5494" marT="5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u="none" strike="noStrike">
                          <a:solidFill>
                            <a:srgbClr val="000000"/>
                          </a:solidFill>
                          <a:effectLst/>
                        </a:rPr>
                        <a:t>Family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494" marR="5494" marT="54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 importance</a:t>
                      </a:r>
                    </a:p>
                  </a:txBody>
                  <a:tcPr marL="5494" marR="5494" marT="5494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000" b="1" u="none" strike="noStrike">
                          <a:effectLst/>
                        </a:rPr>
                        <a:t>Rank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94" marR="5494" marT="5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amily</a:t>
                      </a:r>
                    </a:p>
                  </a:txBody>
                  <a:tcPr marL="5494" marR="5494" marT="5494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 importance</a:t>
                      </a:r>
                    </a:p>
                  </a:txBody>
                  <a:tcPr marL="5494" marR="5494" marT="5494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7454927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licobacteraceae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,95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licobacteraceae</a:t>
                      </a:r>
                    </a:p>
                  </a:txBody>
                  <a:tcPr marL="7620" marR="7620" marT="762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,2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79565031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scirickettsi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,4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scirickettsi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,9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053186951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troph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5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vobacteri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,65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06684783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vobacteri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,5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bulb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7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39891282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thiorhod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,1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ntroph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0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96611113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rochaet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,42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9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225430550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bulb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,6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istensenel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8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963806375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omonad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,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otrich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3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888748924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d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,23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diline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05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43153034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desulfovibrion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,9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irochaet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,42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98450652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rellu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7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055187250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,4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ctothiorhod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0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806171855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diline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5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achn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,65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66505640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pi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,02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omonad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,05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1786616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mmeovirg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,4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uromonad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93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15820744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ristensenel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7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pin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365245365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iotrich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,4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inicel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71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304306906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,6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hod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0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807281598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rucomicrobi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8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itut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4227851055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omorph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obacter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21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60275263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arcul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,1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mmeovirg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8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25848712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brion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81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ewanell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9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00371449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raxell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71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ibrion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73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7352592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inicel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,24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rmodesulfovibrion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2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90468207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rellulacea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,7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omonad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2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604864551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…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[…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728316621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esulfuromonad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,91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rrucomicrobi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,6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36015683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ewanell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ryomorph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,37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434638600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trospin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,3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minococc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59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14117588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pitut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,7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ulfarcul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,6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001348686"/>
                  </a:ext>
                </a:extLst>
              </a:tr>
              <a:tr h="184475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eromonadaceae</a:t>
                      </a:r>
                      <a:r>
                        <a:rPr lang="de-DE" sz="1100" u="none" strike="noStrike" baseline="30000">
                          <a:solidFill>
                            <a:schemeClr val="tx1"/>
                          </a:solidFill>
                          <a:effectLst/>
                        </a:rPr>
                        <a:t>#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,38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raxellaceae*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,3</a:t>
                      </a: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58134523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E43B27C6-7A9B-3141-8251-EBDBA26F3DB5}"/>
              </a:ext>
            </a:extLst>
          </p:cNvPr>
          <p:cNvSpPr txBox="1"/>
          <p:nvPr/>
        </p:nvSpPr>
        <p:spPr>
          <a:xfrm>
            <a:off x="914400" y="609600"/>
            <a:ext cx="2163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le 8</a:t>
            </a:r>
          </a:p>
        </p:txBody>
      </p:sp>
    </p:spTree>
    <p:extLst>
      <p:ext uri="{BB962C8B-B14F-4D97-AF65-F5344CB8AC3E}">
        <p14:creationId xmlns:p14="http://schemas.microsoft.com/office/powerpoint/2010/main" val="2480242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13</Words>
  <Application>Microsoft Macintosh PowerPoint</Application>
  <PresentationFormat>Widescreen</PresentationFormat>
  <Paragraphs>2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erena Dully</dc:creator>
  <cp:lastModifiedBy>stoeck@rhrk.uni-kl.de</cp:lastModifiedBy>
  <cp:revision>14</cp:revision>
  <dcterms:created xsi:type="dcterms:W3CDTF">2021-03-08T09:02:29Z</dcterms:created>
  <dcterms:modified xsi:type="dcterms:W3CDTF">2021-03-12T16:49:16Z</dcterms:modified>
</cp:coreProperties>
</file>